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5" r:id="rId3"/>
    <p:sldId id="268" r:id="rId4"/>
    <p:sldId id="266" r:id="rId5"/>
    <p:sldId id="269" r:id="rId6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D3F4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12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822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2600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928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038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112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349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774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414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724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707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520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14AF7-A2C0-4B15-8C28-28E77D5CC5A8}" type="datetimeFigureOut">
              <a:rPr kumimoji="1" lang="ja-JP" altLang="en-US" smtClean="0"/>
              <a:t>2024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060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E1F28BE-5D63-4BAF-A557-E3350FB77BF5}"/>
              </a:ext>
            </a:extLst>
          </p:cNvPr>
          <p:cNvSpPr txBox="1"/>
          <p:nvPr/>
        </p:nvSpPr>
        <p:spPr>
          <a:xfrm>
            <a:off x="2692033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 Figure S1, Baba I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C215-E266-A1F4-6F7D-6D538F57716E}"/>
              </a:ext>
            </a:extLst>
          </p:cNvPr>
          <p:cNvSpPr txBox="1"/>
          <p:nvPr/>
        </p:nvSpPr>
        <p:spPr>
          <a:xfrm>
            <a:off x="178738" y="7370207"/>
            <a:ext cx="655425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S1. 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Original blots/gels of Figure </a:t>
            </a:r>
            <a:r>
              <a:rPr lang="en-US" altLang="ja-JP" b="1" dirty="0">
                <a:latin typeface="Arial" panose="020B0604020202020204" pitchFamily="34" charset="0"/>
              </a:rPr>
              <a:t>1C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. </a:t>
            </a:r>
            <a:r>
              <a:rPr lang="en-US" altLang="ja-JP" sz="1800" dirty="0">
                <a:effectLst/>
                <a:latin typeface="ArialMT"/>
              </a:rPr>
              <a:t>EVs-NG, EVs secreted by murine peritoneal macrophages under normal glucose conditions;</a:t>
            </a:r>
            <a:r>
              <a:rPr lang="en-US" altLang="ja-JP" dirty="0">
                <a:latin typeface="ArialMT"/>
              </a:rPr>
              <a:t> EVs-HG, EVs</a:t>
            </a:r>
            <a:r>
              <a:rPr lang="en-US" altLang="ja-JP" sz="1800" dirty="0">
                <a:effectLst/>
                <a:latin typeface="ArialMT"/>
              </a:rPr>
              <a:t> secreted by murine peritoneal macrophages under high glucose conditions.</a:t>
            </a:r>
          </a:p>
          <a:p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 highlighted the section cropped by Figure 1C with a red border.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C68BB12-DB09-2C3D-D7D4-C539E126FA81}"/>
              </a:ext>
            </a:extLst>
          </p:cNvPr>
          <p:cNvGrpSpPr/>
          <p:nvPr/>
        </p:nvGrpSpPr>
        <p:grpSpPr>
          <a:xfrm>
            <a:off x="1911022" y="1051688"/>
            <a:ext cx="4040181" cy="6163577"/>
            <a:chOff x="2522668" y="321042"/>
            <a:chExt cx="4040181" cy="6163577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E3F8564B-1D32-E0B0-0EB5-44AF960F60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0785" t="20237" r="49629" b="20606"/>
            <a:stretch/>
          </p:blipFill>
          <p:spPr>
            <a:xfrm>
              <a:off x="3267708" y="399094"/>
              <a:ext cx="1752945" cy="6085525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304E6EE-CD83-7C7D-E42F-8CC726AEA63A}"/>
                </a:ext>
              </a:extLst>
            </p:cNvPr>
            <p:cNvSpPr txBox="1"/>
            <p:nvPr/>
          </p:nvSpPr>
          <p:spPr>
            <a:xfrm>
              <a:off x="2625538" y="4018614"/>
              <a:ext cx="1233086" cy="362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D8E073D-DF24-265D-746C-FD4CAFE62094}"/>
                </a:ext>
              </a:extLst>
            </p:cNvPr>
            <p:cNvSpPr txBox="1"/>
            <p:nvPr/>
          </p:nvSpPr>
          <p:spPr>
            <a:xfrm>
              <a:off x="2525832" y="1361422"/>
              <a:ext cx="1233086" cy="362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25F4434-EAE1-CFF6-64A1-6C28540C83CF}"/>
                </a:ext>
              </a:extLst>
            </p:cNvPr>
            <p:cNvSpPr txBox="1"/>
            <p:nvPr/>
          </p:nvSpPr>
          <p:spPr>
            <a:xfrm>
              <a:off x="2625538" y="4325780"/>
              <a:ext cx="1233086" cy="362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24CE7E0-188C-C93B-D85E-F35688522262}"/>
                </a:ext>
              </a:extLst>
            </p:cNvPr>
            <p:cNvSpPr txBox="1"/>
            <p:nvPr/>
          </p:nvSpPr>
          <p:spPr>
            <a:xfrm>
              <a:off x="2625538" y="4632945"/>
              <a:ext cx="1233086" cy="362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90D8FD3-F9E2-BE7E-A0BD-AD62FDD1C7FC}"/>
                </a:ext>
              </a:extLst>
            </p:cNvPr>
            <p:cNvSpPr txBox="1"/>
            <p:nvPr/>
          </p:nvSpPr>
          <p:spPr>
            <a:xfrm>
              <a:off x="2625538" y="4958607"/>
              <a:ext cx="1233086" cy="362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12FA575F-E6C5-D50B-BC08-3A31A775229D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1542669"/>
              <a:ext cx="171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60720DAC-1750-ED14-5FD3-CFF062C23C22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4187593"/>
              <a:ext cx="171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5E94EE5A-72E2-0381-F18B-0C86EFFE5F12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4497629"/>
              <a:ext cx="171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C3D2EB2E-F3BC-2CA7-700A-FE63E0BE1638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4819903"/>
              <a:ext cx="171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62F08AF5-CD72-92C4-00F9-5376C6857F49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5121780"/>
              <a:ext cx="171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DC8BC94-D7C8-F27C-E542-CE2417451780}"/>
                </a:ext>
              </a:extLst>
            </p:cNvPr>
            <p:cNvCxnSpPr>
              <a:cxnSpLocks/>
            </p:cNvCxnSpPr>
            <p:nvPr/>
          </p:nvCxnSpPr>
          <p:spPr>
            <a:xfrm>
              <a:off x="3557235" y="702010"/>
              <a:ext cx="58694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3F189D4B-BA33-6BE0-176C-E33DE31A832A}"/>
                </a:ext>
              </a:extLst>
            </p:cNvPr>
            <p:cNvCxnSpPr>
              <a:cxnSpLocks/>
            </p:cNvCxnSpPr>
            <p:nvPr/>
          </p:nvCxnSpPr>
          <p:spPr>
            <a:xfrm>
              <a:off x="4222389" y="702010"/>
              <a:ext cx="52009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945C096-0B35-B47F-3717-986423D32054}"/>
                </a:ext>
              </a:extLst>
            </p:cNvPr>
            <p:cNvSpPr txBox="1"/>
            <p:nvPr/>
          </p:nvSpPr>
          <p:spPr>
            <a:xfrm>
              <a:off x="5252209" y="2697571"/>
              <a:ext cx="131064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CD63 (50kDa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線矢印コネクタ 20">
              <a:extLst>
                <a:ext uri="{FF2B5EF4-FFF2-40B4-BE49-F238E27FC236}">
                  <a16:creationId xmlns:a16="http://schemas.microsoft.com/office/drawing/2014/main" id="{E03CA186-1578-0F30-8875-9FD30AAF120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40706" y="3015255"/>
              <a:ext cx="22328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AAAD5CF7-8033-E947-7F71-DCDD4B5A8D66}"/>
                </a:ext>
              </a:extLst>
            </p:cNvPr>
            <p:cNvSpPr txBox="1"/>
            <p:nvPr/>
          </p:nvSpPr>
          <p:spPr>
            <a:xfrm>
              <a:off x="2625538" y="2874531"/>
              <a:ext cx="11087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9457BE2-89CE-43EE-FA37-8299AFB6535D}"/>
                </a:ext>
              </a:extLst>
            </p:cNvPr>
            <p:cNvSpPr txBox="1"/>
            <p:nvPr/>
          </p:nvSpPr>
          <p:spPr>
            <a:xfrm>
              <a:off x="2625538" y="3417197"/>
              <a:ext cx="11087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66E4BB4-36D8-C96B-2C49-F95C45D91117}"/>
                </a:ext>
              </a:extLst>
            </p:cNvPr>
            <p:cNvSpPr txBox="1"/>
            <p:nvPr/>
          </p:nvSpPr>
          <p:spPr>
            <a:xfrm>
              <a:off x="2625538" y="2185994"/>
              <a:ext cx="11087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ECCC1AE4-D36E-47B6-3DBB-F57A2136678C}"/>
                </a:ext>
              </a:extLst>
            </p:cNvPr>
            <p:cNvSpPr txBox="1"/>
            <p:nvPr/>
          </p:nvSpPr>
          <p:spPr>
            <a:xfrm>
              <a:off x="2522668" y="1893160"/>
              <a:ext cx="11087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789EF52F-204A-5E6B-04AC-C4FA89F20233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3575578"/>
              <a:ext cx="1543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98508AA6-DC47-B4D6-1492-162FB339D2B8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2051581"/>
              <a:ext cx="1543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B3CFFA2A-DC2E-C820-59B9-9CA42CEBCE4F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2345491"/>
              <a:ext cx="1543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D6F84A9A-DB2D-7B0F-9DEC-7B83815CAC79}"/>
                </a:ext>
              </a:extLst>
            </p:cNvPr>
            <p:cNvCxnSpPr>
              <a:cxnSpLocks/>
            </p:cNvCxnSpPr>
            <p:nvPr/>
          </p:nvCxnSpPr>
          <p:spPr>
            <a:xfrm>
              <a:off x="3010255" y="3053061"/>
              <a:ext cx="1543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8D756C34-E401-0B70-EDAE-9625D9610DFC}"/>
                </a:ext>
              </a:extLst>
            </p:cNvPr>
            <p:cNvSpPr txBox="1"/>
            <p:nvPr/>
          </p:nvSpPr>
          <p:spPr>
            <a:xfrm>
              <a:off x="3267708" y="321042"/>
              <a:ext cx="16546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EVs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-NG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789A56C-1EDC-5650-006F-8ABA69F50D2D}"/>
                </a:ext>
              </a:extLst>
            </p:cNvPr>
            <p:cNvSpPr txBox="1"/>
            <p:nvPr/>
          </p:nvSpPr>
          <p:spPr>
            <a:xfrm>
              <a:off x="4144180" y="321042"/>
              <a:ext cx="16546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EVs-HG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B7A1A650-CAB1-A799-057A-EB3DBC4FE8AA}"/>
              </a:ext>
            </a:extLst>
          </p:cNvPr>
          <p:cNvSpPr/>
          <p:nvPr/>
        </p:nvSpPr>
        <p:spPr>
          <a:xfrm>
            <a:off x="2688720" y="3333245"/>
            <a:ext cx="1654628" cy="72747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039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FC0C21DC-C0AD-4933-B5F4-A30AA5AF09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2392324"/>
              </p:ext>
            </p:extLst>
          </p:nvPr>
        </p:nvGraphicFramePr>
        <p:xfrm>
          <a:off x="1708035" y="1418581"/>
          <a:ext cx="3067161" cy="49280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000626" imgH="3216977" progId="Prism8.Document">
                  <p:embed/>
                </p:oleObj>
              </mc:Choice>
              <mc:Fallback>
                <p:oleObj name="Prism 8" r:id="rId2" imgW="2000626" imgH="3216977" progId="Prism8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645AF621-BBB8-4147-A896-5538D5C605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08035" y="1418581"/>
                        <a:ext cx="3067161" cy="49280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1C21FC26-4C39-4B0D-A5A9-584C081ED28E}"/>
              </a:ext>
            </a:extLst>
          </p:cNvPr>
          <p:cNvCxnSpPr>
            <a:cxnSpLocks/>
          </p:cNvCxnSpPr>
          <p:nvPr/>
        </p:nvCxnSpPr>
        <p:spPr>
          <a:xfrm>
            <a:off x="3241615" y="2304507"/>
            <a:ext cx="8550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D957B3E-289D-41C8-B807-202B1D696FBC}"/>
              </a:ext>
            </a:extLst>
          </p:cNvPr>
          <p:cNvSpPr txBox="1"/>
          <p:nvPr/>
        </p:nvSpPr>
        <p:spPr>
          <a:xfrm>
            <a:off x="3018402" y="1996730"/>
            <a:ext cx="1563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&lt;1.0x10^-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C215-E266-A1F4-6F7D-6D538F57716E}"/>
              </a:ext>
            </a:extLst>
          </p:cNvPr>
          <p:cNvSpPr txBox="1"/>
          <p:nvPr/>
        </p:nvSpPr>
        <p:spPr>
          <a:xfrm>
            <a:off x="247750" y="7169745"/>
            <a:ext cx="655425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S2. </a:t>
            </a:r>
            <a:r>
              <a:rPr lang="en-GB" altLang="ja-JP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abetes is induced in mice using streptozotocin (STZ)</a:t>
            </a:r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lood glucose levels in control mice and mice with STZ-induced diabetes. The levels of blood glucose in diabetic mice increased significantly compared to those in nondiabetic mice</a:t>
            </a:r>
            <a:r>
              <a:rPr lang="en-GB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The P value was calculated by the unpaired Student’s t test. The data are presented as the mean</a:t>
            </a:r>
            <a:r>
              <a:rPr lang="en-US" altLang="ja-JP" b="0" i="0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± </a:t>
            </a:r>
            <a:r>
              <a:rPr lang="en-GB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M.</a:t>
            </a:r>
            <a:endParaRPr lang="ja-JP" altLang="ja-JP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30C2725-43AE-EFD8-213F-5242EC2B6B6C}"/>
              </a:ext>
            </a:extLst>
          </p:cNvPr>
          <p:cNvSpPr txBox="1"/>
          <p:nvPr/>
        </p:nvSpPr>
        <p:spPr>
          <a:xfrm>
            <a:off x="2692033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 Figure S2, Baba I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96800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C215-E266-A1F4-6F7D-6D538F57716E}"/>
              </a:ext>
            </a:extLst>
          </p:cNvPr>
          <p:cNvSpPr txBox="1"/>
          <p:nvPr/>
        </p:nvSpPr>
        <p:spPr>
          <a:xfrm>
            <a:off x="247750" y="6775521"/>
            <a:ext cx="6554250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S3. 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Original blots/gels of Figure </a:t>
            </a:r>
            <a:r>
              <a:rPr lang="en-US" altLang="ja-JP" b="1" dirty="0">
                <a:latin typeface="Arial" panose="020B0604020202020204" pitchFamily="34" charset="0"/>
              </a:rPr>
              <a:t>3E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. </a:t>
            </a:r>
            <a:r>
              <a:rPr lang="en-US" altLang="ja-JP" sz="1800" dirty="0">
                <a:effectLst/>
                <a:latin typeface="ArialMT"/>
              </a:rPr>
              <a:t>We cannot provide images of full-length blots because we cut membranes before hybridization with antibodies. EVs-NG, MOVAS cells transfected with </a:t>
            </a:r>
            <a:r>
              <a:rPr lang="en-US" altLang="ja-JP" dirty="0">
                <a:latin typeface="ArialMT"/>
              </a:rPr>
              <a:t>EVs</a:t>
            </a:r>
            <a:r>
              <a:rPr lang="en-US" altLang="ja-JP" sz="1800" dirty="0">
                <a:effectLst/>
                <a:latin typeface="ArialMT"/>
              </a:rPr>
              <a:t> secreted by murine peritoneal macrophages under normal glucose conditions; EVs-HG, MOVAS cells transfected with </a:t>
            </a:r>
            <a:r>
              <a:rPr lang="en-US" altLang="ja-JP" dirty="0">
                <a:latin typeface="ArialMT"/>
              </a:rPr>
              <a:t>EVs</a:t>
            </a:r>
            <a:r>
              <a:rPr lang="en-US" altLang="ja-JP" sz="1800" dirty="0">
                <a:effectLst/>
                <a:latin typeface="ArialMT"/>
              </a:rPr>
              <a:t> secreted by murine peritoneal macrophages under high glucose conditions. 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TGF-β RII</a:t>
            </a:r>
            <a:r>
              <a:rPr lang="en-US" altLang="ja-JP" dirty="0">
                <a:latin typeface="Arial" panose="020B0604020202020204" pitchFamily="34" charset="0"/>
              </a:rPr>
              <a:t>,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</a:rPr>
              <a:t>t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ransforming growth factor beta </a:t>
            </a:r>
            <a:r>
              <a:rPr lang="en-US" altLang="ja-JP" dirty="0">
                <a:latin typeface="Arial" panose="020B0604020202020204" pitchFamily="34" charset="0"/>
              </a:rPr>
              <a:t>r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eceptor 2; β-actin</a:t>
            </a:r>
            <a:r>
              <a:rPr lang="en-US" altLang="ja-JP" dirty="0">
                <a:latin typeface="Arial" panose="020B0604020202020204" pitchFamily="34" charset="0"/>
              </a:rPr>
              <a:t>, b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eta actin. </a:t>
            </a:r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 highlighted the section cropped by Figure 3E-Left Panel with a red border.</a:t>
            </a:r>
          </a:p>
          <a:p>
            <a:endParaRPr lang="en-US" altLang="ja-JP" dirty="0">
              <a:effectLst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B1F30DA-1F61-0EF4-CFC3-911115A6D673}"/>
              </a:ext>
            </a:extLst>
          </p:cNvPr>
          <p:cNvSpPr txBox="1"/>
          <p:nvPr/>
        </p:nvSpPr>
        <p:spPr>
          <a:xfrm>
            <a:off x="5369291" y="1748970"/>
            <a:ext cx="14653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GF-β RII</a:t>
            </a:r>
          </a:p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65kD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05E1A33-E0B5-E833-5616-544C268DD8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696" t="43526" r="44167" b="32491"/>
          <a:stretch/>
        </p:blipFill>
        <p:spPr>
          <a:xfrm>
            <a:off x="1395875" y="1102058"/>
            <a:ext cx="3865936" cy="246736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6A134B1-6D2A-1AA6-07C1-0EAE7787B424}"/>
              </a:ext>
            </a:extLst>
          </p:cNvPr>
          <p:cNvSpPr txBox="1"/>
          <p:nvPr/>
        </p:nvSpPr>
        <p:spPr>
          <a:xfrm>
            <a:off x="873974" y="2303815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18A5614-679B-000E-054E-69E74186924A}"/>
              </a:ext>
            </a:extLst>
          </p:cNvPr>
          <p:cNvSpPr txBox="1"/>
          <p:nvPr/>
        </p:nvSpPr>
        <p:spPr>
          <a:xfrm>
            <a:off x="873974" y="2846481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C11E16D-4ECA-B418-D1EE-032A16CFBC23}"/>
              </a:ext>
            </a:extLst>
          </p:cNvPr>
          <p:cNvSpPr txBox="1"/>
          <p:nvPr/>
        </p:nvSpPr>
        <p:spPr>
          <a:xfrm>
            <a:off x="873974" y="1615278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452FB38-4AC6-FB1A-B70D-7287582E1E84}"/>
              </a:ext>
            </a:extLst>
          </p:cNvPr>
          <p:cNvSpPr txBox="1"/>
          <p:nvPr/>
        </p:nvSpPr>
        <p:spPr>
          <a:xfrm>
            <a:off x="771104" y="1322444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D5C4678B-F2AF-40B1-2EB8-970231ACFAFA}"/>
              </a:ext>
            </a:extLst>
          </p:cNvPr>
          <p:cNvCxnSpPr>
            <a:cxnSpLocks/>
          </p:cNvCxnSpPr>
          <p:nvPr/>
        </p:nvCxnSpPr>
        <p:spPr>
          <a:xfrm>
            <a:off x="1269411" y="3004862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8FC224F0-103E-8147-5302-B0EAD1C5A1AD}"/>
              </a:ext>
            </a:extLst>
          </p:cNvPr>
          <p:cNvCxnSpPr>
            <a:cxnSpLocks/>
          </p:cNvCxnSpPr>
          <p:nvPr/>
        </p:nvCxnSpPr>
        <p:spPr>
          <a:xfrm>
            <a:off x="1269411" y="1463280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60DDCC31-6BAC-9CD0-4D1C-8E99D4D6E582}"/>
              </a:ext>
            </a:extLst>
          </p:cNvPr>
          <p:cNvCxnSpPr>
            <a:cxnSpLocks/>
          </p:cNvCxnSpPr>
          <p:nvPr/>
        </p:nvCxnSpPr>
        <p:spPr>
          <a:xfrm>
            <a:off x="1269411" y="1774775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FCEEF886-D58D-12B9-F17D-05BCBBE7F5B7}"/>
              </a:ext>
            </a:extLst>
          </p:cNvPr>
          <p:cNvCxnSpPr>
            <a:cxnSpLocks/>
          </p:cNvCxnSpPr>
          <p:nvPr/>
        </p:nvCxnSpPr>
        <p:spPr>
          <a:xfrm>
            <a:off x="1269411" y="2482345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F498BC20-0143-5A44-60A6-9DB0466042AD}"/>
              </a:ext>
            </a:extLst>
          </p:cNvPr>
          <p:cNvCxnSpPr/>
          <p:nvPr/>
        </p:nvCxnSpPr>
        <p:spPr>
          <a:xfrm>
            <a:off x="1425871" y="1079981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606423D3-A38D-439A-2F43-B85F7A67C3C6}"/>
              </a:ext>
            </a:extLst>
          </p:cNvPr>
          <p:cNvCxnSpPr/>
          <p:nvPr/>
        </p:nvCxnSpPr>
        <p:spPr>
          <a:xfrm>
            <a:off x="3298214" y="1079981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221D51C-D80F-BE3E-AA0C-C688FC3D2196}"/>
              </a:ext>
            </a:extLst>
          </p:cNvPr>
          <p:cNvSpPr txBox="1"/>
          <p:nvPr/>
        </p:nvSpPr>
        <p:spPr>
          <a:xfrm>
            <a:off x="1830259" y="730390"/>
            <a:ext cx="1654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Vs-N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7F614B2-46EE-0D7A-39C7-C60F046D9047}"/>
              </a:ext>
            </a:extLst>
          </p:cNvPr>
          <p:cNvSpPr txBox="1"/>
          <p:nvPr/>
        </p:nvSpPr>
        <p:spPr>
          <a:xfrm>
            <a:off x="3557479" y="730390"/>
            <a:ext cx="1654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Vs-H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8CDDC4E9-28CE-B074-586E-5926A2867DAE}"/>
              </a:ext>
            </a:extLst>
          </p:cNvPr>
          <p:cNvCxnSpPr>
            <a:cxnSpLocks/>
          </p:cNvCxnSpPr>
          <p:nvPr/>
        </p:nvCxnSpPr>
        <p:spPr>
          <a:xfrm flipH="1">
            <a:off x="5251947" y="1915487"/>
            <a:ext cx="2232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図 20">
            <a:extLst>
              <a:ext uri="{FF2B5EF4-FFF2-40B4-BE49-F238E27FC236}">
                <a16:creationId xmlns:a16="http://schemas.microsoft.com/office/drawing/2014/main" id="{3C632322-FF0A-4107-72FF-9EB85B8F55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072" t="40958" r="44789" b="36189"/>
          <a:stretch/>
        </p:blipFill>
        <p:spPr>
          <a:xfrm>
            <a:off x="1395875" y="4257645"/>
            <a:ext cx="3865936" cy="2350781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D5C84B5-6082-D85F-D565-F2D4B2CDFE77}"/>
              </a:ext>
            </a:extLst>
          </p:cNvPr>
          <p:cNvSpPr txBox="1"/>
          <p:nvPr/>
        </p:nvSpPr>
        <p:spPr>
          <a:xfrm>
            <a:off x="808826" y="5348733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CFBB05B-9E09-E292-C1FA-8321C47A1EF9}"/>
              </a:ext>
            </a:extLst>
          </p:cNvPr>
          <p:cNvSpPr txBox="1"/>
          <p:nvPr/>
        </p:nvSpPr>
        <p:spPr>
          <a:xfrm>
            <a:off x="808826" y="5891399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476D608-7E6A-4B70-2AA5-86E4D8B73BCE}"/>
              </a:ext>
            </a:extLst>
          </p:cNvPr>
          <p:cNvSpPr txBox="1"/>
          <p:nvPr/>
        </p:nvSpPr>
        <p:spPr>
          <a:xfrm>
            <a:off x="808826" y="4660196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F598F13-01B5-43D0-22F9-32A3DBA05E35}"/>
              </a:ext>
            </a:extLst>
          </p:cNvPr>
          <p:cNvSpPr txBox="1"/>
          <p:nvPr/>
        </p:nvSpPr>
        <p:spPr>
          <a:xfrm>
            <a:off x="705956" y="4367362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6F0199B-2580-02FD-9A9E-77E52D34F5B3}"/>
              </a:ext>
            </a:extLst>
          </p:cNvPr>
          <p:cNvCxnSpPr>
            <a:cxnSpLocks/>
          </p:cNvCxnSpPr>
          <p:nvPr/>
        </p:nvCxnSpPr>
        <p:spPr>
          <a:xfrm>
            <a:off x="1204263" y="6049780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1D36DA90-17F6-14A6-0900-470A7D16671D}"/>
              </a:ext>
            </a:extLst>
          </p:cNvPr>
          <p:cNvCxnSpPr>
            <a:cxnSpLocks/>
          </p:cNvCxnSpPr>
          <p:nvPr/>
        </p:nvCxnSpPr>
        <p:spPr>
          <a:xfrm>
            <a:off x="1204263" y="4525782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071F00F-001D-A103-AA31-D336FC3C5755}"/>
              </a:ext>
            </a:extLst>
          </p:cNvPr>
          <p:cNvCxnSpPr>
            <a:cxnSpLocks/>
          </p:cNvCxnSpPr>
          <p:nvPr/>
        </p:nvCxnSpPr>
        <p:spPr>
          <a:xfrm>
            <a:off x="1204263" y="4819693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21AF777D-9503-ABEE-2A85-F93DED71552C}"/>
              </a:ext>
            </a:extLst>
          </p:cNvPr>
          <p:cNvCxnSpPr>
            <a:cxnSpLocks/>
          </p:cNvCxnSpPr>
          <p:nvPr/>
        </p:nvCxnSpPr>
        <p:spPr>
          <a:xfrm>
            <a:off x="1204263" y="5527263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C3B03D3-5E19-5C6A-18A9-C346CECD1050}"/>
              </a:ext>
            </a:extLst>
          </p:cNvPr>
          <p:cNvCxnSpPr/>
          <p:nvPr/>
        </p:nvCxnSpPr>
        <p:spPr>
          <a:xfrm>
            <a:off x="1435658" y="4212247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AAED0271-97FD-5597-5536-5C2D022CCE18}"/>
              </a:ext>
            </a:extLst>
          </p:cNvPr>
          <p:cNvCxnSpPr/>
          <p:nvPr/>
        </p:nvCxnSpPr>
        <p:spPr>
          <a:xfrm>
            <a:off x="3308001" y="4212247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5B0D09C-0F3C-CF46-916A-3DDBF34F84B8}"/>
              </a:ext>
            </a:extLst>
          </p:cNvPr>
          <p:cNvSpPr txBox="1"/>
          <p:nvPr/>
        </p:nvSpPr>
        <p:spPr>
          <a:xfrm>
            <a:off x="5485095" y="5470821"/>
            <a:ext cx="10299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β-actin (43kD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C0FE035-CA54-F97D-73D7-87F767FACC35}"/>
              </a:ext>
            </a:extLst>
          </p:cNvPr>
          <p:cNvSpPr txBox="1"/>
          <p:nvPr/>
        </p:nvSpPr>
        <p:spPr>
          <a:xfrm>
            <a:off x="1830259" y="3862656"/>
            <a:ext cx="1654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Vs-N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1CB4DDF-6186-B315-6415-5993D66EC4EA}"/>
              </a:ext>
            </a:extLst>
          </p:cNvPr>
          <p:cNvSpPr txBox="1"/>
          <p:nvPr/>
        </p:nvSpPr>
        <p:spPr>
          <a:xfrm>
            <a:off x="3557479" y="3862656"/>
            <a:ext cx="1654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Vs-H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16639804-DC96-D7C4-1E28-D8ACE0C76546}"/>
              </a:ext>
            </a:extLst>
          </p:cNvPr>
          <p:cNvCxnSpPr>
            <a:cxnSpLocks/>
          </p:cNvCxnSpPr>
          <p:nvPr/>
        </p:nvCxnSpPr>
        <p:spPr>
          <a:xfrm flipH="1">
            <a:off x="5261811" y="5655488"/>
            <a:ext cx="2232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1E5F362D-97F2-74ED-6AD4-B097EE8DAC6D}"/>
              </a:ext>
            </a:extLst>
          </p:cNvPr>
          <p:cNvSpPr/>
          <p:nvPr/>
        </p:nvSpPr>
        <p:spPr>
          <a:xfrm>
            <a:off x="1423716" y="5450038"/>
            <a:ext cx="3795573" cy="59974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1D9ED642-00B3-1056-AAE3-D6C714C73269}"/>
              </a:ext>
            </a:extLst>
          </p:cNvPr>
          <p:cNvSpPr/>
          <p:nvPr/>
        </p:nvSpPr>
        <p:spPr>
          <a:xfrm>
            <a:off x="1395875" y="1783402"/>
            <a:ext cx="3823414" cy="34886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B426276-51CE-77EA-AC75-5B9772CE5E3A}"/>
              </a:ext>
            </a:extLst>
          </p:cNvPr>
          <p:cNvSpPr txBox="1"/>
          <p:nvPr/>
        </p:nvSpPr>
        <p:spPr>
          <a:xfrm>
            <a:off x="2692033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 Figure S3, Baba I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1345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C215-E266-A1F4-6F7D-6D538F57716E}"/>
              </a:ext>
            </a:extLst>
          </p:cNvPr>
          <p:cNvSpPr txBox="1"/>
          <p:nvPr/>
        </p:nvSpPr>
        <p:spPr>
          <a:xfrm>
            <a:off x="179614" y="7102337"/>
            <a:ext cx="6678386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S4. 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Original blots/gels of Figure </a:t>
            </a:r>
            <a:r>
              <a:rPr lang="en-US" altLang="ja-JP" b="1" dirty="0">
                <a:latin typeface="Arial" panose="020B0604020202020204" pitchFamily="34" charset="0"/>
              </a:rPr>
              <a:t>3E</a:t>
            </a:r>
            <a:r>
              <a:rPr lang="en-US" altLang="ja-JP" sz="1800" b="1" dirty="0">
                <a:effectLst/>
                <a:latin typeface="Arial" panose="020B0604020202020204" pitchFamily="34" charset="0"/>
              </a:rPr>
              <a:t>.</a:t>
            </a:r>
            <a:r>
              <a:rPr lang="en-US" altLang="ja-JP" b="1" dirty="0">
                <a:latin typeface="Arial" panose="020B0604020202020204" pitchFamily="34" charset="0"/>
              </a:rPr>
              <a:t> </a:t>
            </a:r>
            <a:r>
              <a:rPr lang="en-US" altLang="ja-JP" sz="1800" dirty="0">
                <a:effectLst/>
                <a:latin typeface="ArialMT"/>
              </a:rPr>
              <a:t>We cannot provide images of full-length blots because we cut membranes before hybridization with antibodies. </a:t>
            </a:r>
            <a:r>
              <a:rPr lang="en-US" altLang="ja-JP" dirty="0">
                <a:latin typeface="Arial" panose="020B0604020202020204" pitchFamily="34" charset="0"/>
              </a:rPr>
              <a:t>Control mimic,  MOVAS cells transfected with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 miRNA mimic negative control using lipid nanoparticles; miR-17-5p mimic, MOVAS cells transfected with miR-17-5p mimic using lipid nanoparticles. TGF-β RII</a:t>
            </a:r>
            <a:r>
              <a:rPr lang="en-US" altLang="ja-JP" dirty="0">
                <a:latin typeface="Arial" panose="020B0604020202020204" pitchFamily="34" charset="0"/>
              </a:rPr>
              <a:t>,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</a:rPr>
              <a:t>t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ransforming growth factor beta </a:t>
            </a:r>
            <a:r>
              <a:rPr lang="en-US" altLang="ja-JP" dirty="0">
                <a:latin typeface="Arial" panose="020B0604020202020204" pitchFamily="34" charset="0"/>
              </a:rPr>
              <a:t>r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eceptor 2; β-actin</a:t>
            </a:r>
            <a:r>
              <a:rPr lang="en-US" altLang="ja-JP" dirty="0">
                <a:latin typeface="Arial" panose="020B0604020202020204" pitchFamily="34" charset="0"/>
              </a:rPr>
              <a:t>, b</a:t>
            </a:r>
            <a:r>
              <a:rPr lang="en-US" altLang="ja-JP" sz="1800" dirty="0">
                <a:effectLst/>
                <a:latin typeface="Arial" panose="020B0604020202020204" pitchFamily="34" charset="0"/>
              </a:rPr>
              <a:t>eta actin. </a:t>
            </a:r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 highlighted the section cropped by Figure 3E-Right Panel with a red border.</a:t>
            </a:r>
          </a:p>
          <a:p>
            <a:endParaRPr lang="en-US" altLang="ja-JP" dirty="0">
              <a:effectLst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597909A-AAF1-BFED-1679-1762038EEA53}"/>
              </a:ext>
            </a:extLst>
          </p:cNvPr>
          <p:cNvSpPr txBox="1"/>
          <p:nvPr/>
        </p:nvSpPr>
        <p:spPr>
          <a:xfrm>
            <a:off x="1541786" y="666229"/>
            <a:ext cx="1765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7F4FFDB-35EB-3759-3A1F-E8BDD821581C}"/>
              </a:ext>
            </a:extLst>
          </p:cNvPr>
          <p:cNvSpPr txBox="1"/>
          <p:nvPr/>
        </p:nvSpPr>
        <p:spPr>
          <a:xfrm>
            <a:off x="3327847" y="666229"/>
            <a:ext cx="21123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R-17-5p mimi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5DB8E86-2632-4EEE-AC2A-92E3CB9A9051}"/>
              </a:ext>
            </a:extLst>
          </p:cNvPr>
          <p:cNvSpPr txBox="1"/>
          <p:nvPr/>
        </p:nvSpPr>
        <p:spPr>
          <a:xfrm>
            <a:off x="5315677" y="1791569"/>
            <a:ext cx="14653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GF-β RII</a:t>
            </a:r>
          </a:p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65kD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58497B57-9902-4C43-75DE-B259EA3925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025" t="40294" r="34415" b="39649"/>
          <a:stretch/>
        </p:blipFill>
        <p:spPr>
          <a:xfrm>
            <a:off x="1548970" y="4942261"/>
            <a:ext cx="3760060" cy="2063271"/>
          </a:xfrm>
          <a:prstGeom prst="rect">
            <a:avLst/>
          </a:prstGeom>
        </p:spPr>
      </p:pic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5F4CCCD2-199C-2FA0-1057-04F6C03D2CDF}"/>
              </a:ext>
            </a:extLst>
          </p:cNvPr>
          <p:cNvCxnSpPr/>
          <p:nvPr/>
        </p:nvCxnSpPr>
        <p:spPr>
          <a:xfrm>
            <a:off x="1503058" y="4886644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4BFDE355-D733-2453-35EF-3C168D9C24D8}"/>
              </a:ext>
            </a:extLst>
          </p:cNvPr>
          <p:cNvCxnSpPr/>
          <p:nvPr/>
        </p:nvCxnSpPr>
        <p:spPr>
          <a:xfrm>
            <a:off x="3375401" y="4886644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97EAF71-C509-EB84-64AA-DFAA4BE1B0BB}"/>
              </a:ext>
            </a:extLst>
          </p:cNvPr>
          <p:cNvSpPr txBox="1"/>
          <p:nvPr/>
        </p:nvSpPr>
        <p:spPr>
          <a:xfrm>
            <a:off x="1541786" y="4537053"/>
            <a:ext cx="1730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3C10127-50D3-EBA7-37F8-3BCD16C8DE03}"/>
              </a:ext>
            </a:extLst>
          </p:cNvPr>
          <p:cNvSpPr txBox="1"/>
          <p:nvPr/>
        </p:nvSpPr>
        <p:spPr>
          <a:xfrm>
            <a:off x="3327847" y="4537053"/>
            <a:ext cx="21123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R-17-5p mimi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689F6CF-A1E1-5827-D224-25DFC3836965}"/>
              </a:ext>
            </a:extLst>
          </p:cNvPr>
          <p:cNvSpPr txBox="1"/>
          <p:nvPr/>
        </p:nvSpPr>
        <p:spPr>
          <a:xfrm>
            <a:off x="5406652" y="6094940"/>
            <a:ext cx="10299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β-actin (43kD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25D98075-B75D-05A2-4E47-E123D39CE18A}"/>
              </a:ext>
            </a:extLst>
          </p:cNvPr>
          <p:cNvCxnSpPr>
            <a:cxnSpLocks/>
          </p:cNvCxnSpPr>
          <p:nvPr/>
        </p:nvCxnSpPr>
        <p:spPr>
          <a:xfrm flipH="1">
            <a:off x="5232355" y="6271858"/>
            <a:ext cx="2232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5" name="図 14">
            <a:extLst>
              <a:ext uri="{FF2B5EF4-FFF2-40B4-BE49-F238E27FC236}">
                <a16:creationId xmlns:a16="http://schemas.microsoft.com/office/drawing/2014/main" id="{3E3E8173-945F-96FF-825A-38602F93AB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639" t="42308" r="35040" b="30095"/>
          <a:stretch/>
        </p:blipFill>
        <p:spPr>
          <a:xfrm>
            <a:off x="1503058" y="998932"/>
            <a:ext cx="3716459" cy="3593312"/>
          </a:xfrm>
          <a:prstGeom prst="rect">
            <a:avLst/>
          </a:prstGeom>
        </p:spPr>
      </p:pic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567919BF-5AE7-95DB-42F4-2894EBBF191E}"/>
              </a:ext>
            </a:extLst>
          </p:cNvPr>
          <p:cNvCxnSpPr/>
          <p:nvPr/>
        </p:nvCxnSpPr>
        <p:spPr>
          <a:xfrm>
            <a:off x="1475637" y="1023892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104FE3FD-3E4D-697A-8AEE-4C3A28FFAD50}"/>
              </a:ext>
            </a:extLst>
          </p:cNvPr>
          <p:cNvCxnSpPr/>
          <p:nvPr/>
        </p:nvCxnSpPr>
        <p:spPr>
          <a:xfrm>
            <a:off x="3347980" y="1023892"/>
            <a:ext cx="17308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3A1D0216-78AF-83F4-7864-62CBEC0E3B39}"/>
              </a:ext>
            </a:extLst>
          </p:cNvPr>
          <p:cNvCxnSpPr>
            <a:cxnSpLocks/>
          </p:cNvCxnSpPr>
          <p:nvPr/>
        </p:nvCxnSpPr>
        <p:spPr>
          <a:xfrm flipH="1">
            <a:off x="5180592" y="1987137"/>
            <a:ext cx="2232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A1C62A0-BFA6-F30B-23DD-C5D6C850A7B0}"/>
              </a:ext>
            </a:extLst>
          </p:cNvPr>
          <p:cNvSpPr txBox="1"/>
          <p:nvPr/>
        </p:nvSpPr>
        <p:spPr>
          <a:xfrm>
            <a:off x="941790" y="2329810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C3157DC-01B7-43C2-C79D-6832E2E6EFE4}"/>
              </a:ext>
            </a:extLst>
          </p:cNvPr>
          <p:cNvSpPr txBox="1"/>
          <p:nvPr/>
        </p:nvSpPr>
        <p:spPr>
          <a:xfrm>
            <a:off x="941790" y="2872476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1B41015-DCB5-AA33-D00E-1019F9A20F93}"/>
              </a:ext>
            </a:extLst>
          </p:cNvPr>
          <p:cNvSpPr txBox="1"/>
          <p:nvPr/>
        </p:nvSpPr>
        <p:spPr>
          <a:xfrm>
            <a:off x="941790" y="1610277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27158D3-FBF4-6E16-DF83-830EE530CA31}"/>
              </a:ext>
            </a:extLst>
          </p:cNvPr>
          <p:cNvSpPr txBox="1"/>
          <p:nvPr/>
        </p:nvSpPr>
        <p:spPr>
          <a:xfrm>
            <a:off x="838920" y="1278698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74F2E41B-EC4F-882D-E8BA-47724644BB62}"/>
              </a:ext>
            </a:extLst>
          </p:cNvPr>
          <p:cNvCxnSpPr>
            <a:cxnSpLocks/>
          </p:cNvCxnSpPr>
          <p:nvPr/>
        </p:nvCxnSpPr>
        <p:spPr>
          <a:xfrm>
            <a:off x="1337227" y="3054104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A9D25DA-111E-E3A3-37A9-366BB4240445}"/>
              </a:ext>
            </a:extLst>
          </p:cNvPr>
          <p:cNvCxnSpPr>
            <a:cxnSpLocks/>
          </p:cNvCxnSpPr>
          <p:nvPr/>
        </p:nvCxnSpPr>
        <p:spPr>
          <a:xfrm>
            <a:off x="1337227" y="1444868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F6206F9-0020-F791-E4AE-AF7FE498DA0C}"/>
              </a:ext>
            </a:extLst>
          </p:cNvPr>
          <p:cNvCxnSpPr>
            <a:cxnSpLocks/>
          </p:cNvCxnSpPr>
          <p:nvPr/>
        </p:nvCxnSpPr>
        <p:spPr>
          <a:xfrm>
            <a:off x="1337227" y="1777523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90B1A8AF-9B1E-1DDF-C094-1EB36584C4FF}"/>
              </a:ext>
            </a:extLst>
          </p:cNvPr>
          <p:cNvCxnSpPr>
            <a:cxnSpLocks/>
          </p:cNvCxnSpPr>
          <p:nvPr/>
        </p:nvCxnSpPr>
        <p:spPr>
          <a:xfrm>
            <a:off x="1337227" y="2508340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DB1F695-FED5-DF51-D3A4-1FFC2B48F1D3}"/>
              </a:ext>
            </a:extLst>
          </p:cNvPr>
          <p:cNvSpPr txBox="1"/>
          <p:nvPr/>
        </p:nvSpPr>
        <p:spPr>
          <a:xfrm>
            <a:off x="957118" y="5894940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BA78BB1-528B-DA6F-B1F6-43A65945C0A7}"/>
              </a:ext>
            </a:extLst>
          </p:cNvPr>
          <p:cNvSpPr txBox="1"/>
          <p:nvPr/>
        </p:nvSpPr>
        <p:spPr>
          <a:xfrm>
            <a:off x="957118" y="6437606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535EFA8-8060-B870-AB10-AEA4988E9DBF}"/>
              </a:ext>
            </a:extLst>
          </p:cNvPr>
          <p:cNvSpPr txBox="1"/>
          <p:nvPr/>
        </p:nvSpPr>
        <p:spPr>
          <a:xfrm>
            <a:off x="957118" y="5175407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DB19537-6B95-9B41-B115-CAC6182FB341}"/>
              </a:ext>
            </a:extLst>
          </p:cNvPr>
          <p:cNvSpPr txBox="1"/>
          <p:nvPr/>
        </p:nvSpPr>
        <p:spPr>
          <a:xfrm>
            <a:off x="854248" y="4843828"/>
            <a:ext cx="110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3C10E876-F494-2385-125A-E2F120C529E7}"/>
              </a:ext>
            </a:extLst>
          </p:cNvPr>
          <p:cNvCxnSpPr>
            <a:cxnSpLocks/>
          </p:cNvCxnSpPr>
          <p:nvPr/>
        </p:nvCxnSpPr>
        <p:spPr>
          <a:xfrm>
            <a:off x="1352555" y="6619234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1D8E4C5B-15D5-C697-4679-95C14864CBF3}"/>
              </a:ext>
            </a:extLst>
          </p:cNvPr>
          <p:cNvCxnSpPr>
            <a:cxnSpLocks/>
          </p:cNvCxnSpPr>
          <p:nvPr/>
        </p:nvCxnSpPr>
        <p:spPr>
          <a:xfrm>
            <a:off x="1352555" y="5009998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B8E9E321-EA23-4E47-CD50-52FADA1E529E}"/>
              </a:ext>
            </a:extLst>
          </p:cNvPr>
          <p:cNvCxnSpPr>
            <a:cxnSpLocks/>
          </p:cNvCxnSpPr>
          <p:nvPr/>
        </p:nvCxnSpPr>
        <p:spPr>
          <a:xfrm>
            <a:off x="1352555" y="5342653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028866D4-F0BC-301A-79C6-B85224352233}"/>
              </a:ext>
            </a:extLst>
          </p:cNvPr>
          <p:cNvCxnSpPr>
            <a:cxnSpLocks/>
          </p:cNvCxnSpPr>
          <p:nvPr/>
        </p:nvCxnSpPr>
        <p:spPr>
          <a:xfrm>
            <a:off x="1352555" y="6073470"/>
            <a:ext cx="1543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8F8997DC-1E85-60B6-056A-41DA94CC015A}"/>
              </a:ext>
            </a:extLst>
          </p:cNvPr>
          <p:cNvSpPr/>
          <p:nvPr/>
        </p:nvSpPr>
        <p:spPr>
          <a:xfrm>
            <a:off x="1548970" y="6020718"/>
            <a:ext cx="3670548" cy="56585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9A060874-93F7-6E7E-6EEF-6420B5570F1A}"/>
              </a:ext>
            </a:extLst>
          </p:cNvPr>
          <p:cNvSpPr/>
          <p:nvPr/>
        </p:nvSpPr>
        <p:spPr>
          <a:xfrm>
            <a:off x="1491531" y="1810181"/>
            <a:ext cx="3674103" cy="42522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34116AF-91BE-62FA-B409-A98FEB2963D6}"/>
              </a:ext>
            </a:extLst>
          </p:cNvPr>
          <p:cNvSpPr txBox="1"/>
          <p:nvPr/>
        </p:nvSpPr>
        <p:spPr>
          <a:xfrm>
            <a:off x="2692033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 Figure S4, Baba I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269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93B53A5F-D92E-4CD2-8D94-9104272C6D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227284"/>
              </p:ext>
            </p:extLst>
          </p:nvPr>
        </p:nvGraphicFramePr>
        <p:xfrm>
          <a:off x="1554326" y="1209926"/>
          <a:ext cx="3332971" cy="5549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22425" imgH="3867428" progId="Prism8.Document">
                  <p:embed/>
                </p:oleObj>
              </mc:Choice>
              <mc:Fallback>
                <p:oleObj name="Prism 8" r:id="rId2" imgW="2322425" imgH="3867428" progId="Prism8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93B53A5F-D92E-4CD2-8D94-9104272C6D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54326" y="1209926"/>
                        <a:ext cx="3332971" cy="5549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3EB5BFC-F4D6-4A8B-9782-D2379EC2EA4F}"/>
              </a:ext>
            </a:extLst>
          </p:cNvPr>
          <p:cNvSpPr txBox="1"/>
          <p:nvPr/>
        </p:nvSpPr>
        <p:spPr>
          <a:xfrm>
            <a:off x="3058821" y="1783131"/>
            <a:ext cx="1563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.2x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^-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AC4F645-621E-4911-ACDF-9C9A949BBC1C}"/>
              </a:ext>
            </a:extLst>
          </p:cNvPr>
          <p:cNvCxnSpPr>
            <a:cxnSpLocks/>
          </p:cNvCxnSpPr>
          <p:nvPr/>
        </p:nvCxnSpPr>
        <p:spPr>
          <a:xfrm>
            <a:off x="3220812" y="2042200"/>
            <a:ext cx="62875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C215-E266-A1F4-6F7D-6D538F57716E}"/>
              </a:ext>
            </a:extLst>
          </p:cNvPr>
          <p:cNvSpPr txBox="1"/>
          <p:nvPr/>
        </p:nvSpPr>
        <p:spPr>
          <a:xfrm>
            <a:off x="222251" y="6664749"/>
            <a:ext cx="6446219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S5. High phosphate medium increased Runx2 expression</a:t>
            </a:r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ne expression levels of Runx2</a:t>
            </a:r>
            <a:r>
              <a:rPr lang="en-GB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 VSMCs stimulated with control or osteogenic medium 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ere measured by RT-PCR. GAPDH was used as the endogenous control. The P value was calculated by the Mann-Whitney U test. The data are presented as the </a:t>
            </a:r>
            <a:r>
              <a:rPr lang="en-GB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an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b="0" i="0" u="none" strike="noStrike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GB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M.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996F751-3C8E-9888-EEE1-DD004E7EAA16}"/>
              </a:ext>
            </a:extLst>
          </p:cNvPr>
          <p:cNvSpPr txBox="1"/>
          <p:nvPr/>
        </p:nvSpPr>
        <p:spPr>
          <a:xfrm>
            <a:off x="2692033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 Figure S5, Baba I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9545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6</TotalTime>
  <Words>466</Words>
  <Application>Microsoft Macintosh PowerPoint</Application>
  <PresentationFormat>A4 210 x 297 mm</PresentationFormat>
  <Paragraphs>55</Paragraphs>
  <Slides>5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ArialMT</vt:lpstr>
      <vt:lpstr>Arial</vt:lpstr>
      <vt:lpstr>Calibri</vt:lpstr>
      <vt:lpstr>Calibri Light</vt:lpstr>
      <vt:lpstr>Office テーマ</vt:lpstr>
      <vt:lpstr>Prism 8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馬場功士</dc:creator>
  <cp:lastModifiedBy>功士 馬場</cp:lastModifiedBy>
  <cp:revision>936</cp:revision>
  <dcterms:created xsi:type="dcterms:W3CDTF">2022-09-24T04:32:08Z</dcterms:created>
  <dcterms:modified xsi:type="dcterms:W3CDTF">2024-04-18T10:13:42Z</dcterms:modified>
</cp:coreProperties>
</file>